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8" r:id="rId2"/>
    <p:sldId id="26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52" autoAdjust="0"/>
    <p:restoredTop sz="94741" autoAdjust="0"/>
  </p:normalViewPr>
  <p:slideViewPr>
    <p:cSldViewPr>
      <p:cViewPr varScale="1">
        <p:scale>
          <a:sx n="114" d="100"/>
          <a:sy n="114" d="100"/>
        </p:scale>
        <p:origin x="536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72B9A4-1490-4B1F-A9F2-5CDCEE2180A0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D99FDF-C638-490B-872B-DDA4A65F4C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1373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712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748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8625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6782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1121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062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367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294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574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5061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767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897B5-C02F-4BF5-86E5-461EA11B9C05}" type="datetimeFigureOut">
              <a:rPr lang="en-GB" smtClean="0"/>
              <a:t>05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AAD40-EDE0-4F45-BCBE-7468B2CBB6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80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1F65A61-87EC-0E4E-98C6-A82228939D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868" t="36116" r="33495" b="22821"/>
          <a:stretch/>
        </p:blipFill>
        <p:spPr>
          <a:xfrm>
            <a:off x="1999890" y="1609391"/>
            <a:ext cx="4345518" cy="36392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597C468-9BC0-6043-8E4D-BB8E0D9098DB}"/>
              </a:ext>
            </a:extLst>
          </p:cNvPr>
          <p:cNvSpPr txBox="1"/>
          <p:nvPr/>
        </p:nvSpPr>
        <p:spPr>
          <a:xfrm>
            <a:off x="4656327" y="804578"/>
            <a:ext cx="977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/WT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B929483-1F5B-E14F-BE56-F0FCAA047DE1}"/>
              </a:ext>
            </a:extLst>
          </p:cNvPr>
          <p:cNvSpPr/>
          <p:nvPr/>
        </p:nvSpPr>
        <p:spPr>
          <a:xfrm>
            <a:off x="1937423" y="700697"/>
            <a:ext cx="19191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lang="x-none"/>
            </a:pPr>
            <a:r>
              <a:rPr lang="x-non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TX, c.879C&gt;T</a:t>
            </a:r>
          </a:p>
          <a:p>
            <a:pPr algn="ctr">
              <a:defRPr lang="x-none"/>
            </a:pP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.W279*</a:t>
            </a:r>
          </a:p>
          <a:p>
            <a:pPr algn="ctr">
              <a:defRPr lang="x-none"/>
            </a:pPr>
            <a:endParaRPr lang="x-none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 lang="x-none"/>
            </a:pPr>
            <a:r>
              <a:rPr lang="x-non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2B41BEE-A898-4E4E-9E9E-980677E7EFB9}"/>
              </a:ext>
            </a:extLst>
          </p:cNvPr>
          <p:cNvSpPr txBox="1"/>
          <p:nvPr/>
        </p:nvSpPr>
        <p:spPr>
          <a:xfrm rot="17752308">
            <a:off x="2275252" y="1085867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0DC44B-00E8-3E4C-B9CC-BAEB3B255BD3}"/>
              </a:ext>
            </a:extLst>
          </p:cNvPr>
          <p:cNvSpPr txBox="1"/>
          <p:nvPr/>
        </p:nvSpPr>
        <p:spPr>
          <a:xfrm rot="17752308">
            <a:off x="2729357" y="1130473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92F7F4-7EDD-4949-94AD-883E80463C3B}"/>
              </a:ext>
            </a:extLst>
          </p:cNvPr>
          <p:cNvSpPr txBox="1"/>
          <p:nvPr/>
        </p:nvSpPr>
        <p:spPr>
          <a:xfrm rot="17752308">
            <a:off x="3204483" y="1118108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43DF6A-FB01-0543-A680-EDD7122A7BCF}"/>
              </a:ext>
            </a:extLst>
          </p:cNvPr>
          <p:cNvSpPr txBox="1"/>
          <p:nvPr/>
        </p:nvSpPr>
        <p:spPr>
          <a:xfrm rot="17752308">
            <a:off x="3690502" y="1095586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302205D-8444-BE4A-8715-FFD185F6ECFB}"/>
              </a:ext>
            </a:extLst>
          </p:cNvPr>
          <p:cNvSpPr txBox="1"/>
          <p:nvPr/>
        </p:nvSpPr>
        <p:spPr>
          <a:xfrm rot="17752308">
            <a:off x="4174181" y="1085867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EF73EC-C89B-5740-B1B5-D3EE3871CD7A}"/>
              </a:ext>
            </a:extLst>
          </p:cNvPr>
          <p:cNvSpPr txBox="1"/>
          <p:nvPr/>
        </p:nvSpPr>
        <p:spPr>
          <a:xfrm rot="17752308">
            <a:off x="5668238" y="1130472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65BEDAF-220A-7347-9BEF-22870AA27FD0}"/>
              </a:ext>
            </a:extLst>
          </p:cNvPr>
          <p:cNvSpPr txBox="1"/>
          <p:nvPr/>
        </p:nvSpPr>
        <p:spPr>
          <a:xfrm rot="17752308">
            <a:off x="5184027" y="1118108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4CA8DB-0F70-464A-A2D2-575BCF4004C4}"/>
              </a:ext>
            </a:extLst>
          </p:cNvPr>
          <p:cNvSpPr txBox="1"/>
          <p:nvPr/>
        </p:nvSpPr>
        <p:spPr>
          <a:xfrm rot="17752308">
            <a:off x="4678962" y="1118109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3C2FB12-2411-384A-806E-F594C2F1384C}"/>
              </a:ext>
            </a:extLst>
          </p:cNvPr>
          <p:cNvSpPr txBox="1"/>
          <p:nvPr/>
        </p:nvSpPr>
        <p:spPr>
          <a:xfrm>
            <a:off x="1036414" y="2525298"/>
            <a:ext cx="11775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sz="16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7AE4221-D60A-B640-9CE5-CF6180627B16}"/>
              </a:ext>
            </a:extLst>
          </p:cNvPr>
          <p:cNvSpPr/>
          <p:nvPr/>
        </p:nvSpPr>
        <p:spPr>
          <a:xfrm>
            <a:off x="-38895" y="4216136"/>
            <a:ext cx="1025660" cy="3828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888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sz="1888" dirty="0" err="1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888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BF7B7B-B492-F94B-8495-81AA05923F2C}"/>
              </a:ext>
            </a:extLst>
          </p:cNvPr>
          <p:cNvSpPr txBox="1"/>
          <p:nvPr/>
        </p:nvSpPr>
        <p:spPr>
          <a:xfrm>
            <a:off x="4955105" y="4103302"/>
            <a:ext cx="858339" cy="468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888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888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1EA92C6-B37D-894D-93B5-5FF3BB799041}"/>
              </a:ext>
            </a:extLst>
          </p:cNvPr>
          <p:cNvSpPr txBox="1"/>
          <p:nvPr/>
        </p:nvSpPr>
        <p:spPr>
          <a:xfrm>
            <a:off x="6341362" y="2445009"/>
            <a:ext cx="12382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rataxin</a:t>
            </a:r>
            <a:endParaRPr 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08A4F3F-ED99-544A-9381-DCA9611DADA9}"/>
              </a:ext>
            </a:extLst>
          </p:cNvPr>
          <p:cNvCxnSpPr/>
          <p:nvPr/>
        </p:nvCxnSpPr>
        <p:spPr>
          <a:xfrm>
            <a:off x="1867009" y="2776469"/>
            <a:ext cx="1782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ADD8321-AD36-D64C-9CFE-60FB3DAD17B3}"/>
              </a:ext>
            </a:extLst>
          </p:cNvPr>
          <p:cNvCxnSpPr/>
          <p:nvPr/>
        </p:nvCxnSpPr>
        <p:spPr>
          <a:xfrm flipV="1">
            <a:off x="4337140" y="1171115"/>
            <a:ext cx="1750379" cy="796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ABFDA3B-D7AF-5449-BD77-833ED922EA13}"/>
              </a:ext>
            </a:extLst>
          </p:cNvPr>
          <p:cNvCxnSpPr/>
          <p:nvPr/>
        </p:nvCxnSpPr>
        <p:spPr>
          <a:xfrm flipV="1">
            <a:off x="2070519" y="1179081"/>
            <a:ext cx="1750379" cy="796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357008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597C468-9BC0-6043-8E4D-BB8E0D9098DB}"/>
              </a:ext>
            </a:extLst>
          </p:cNvPr>
          <p:cNvSpPr txBox="1"/>
          <p:nvPr/>
        </p:nvSpPr>
        <p:spPr>
          <a:xfrm>
            <a:off x="4656327" y="804578"/>
            <a:ext cx="977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/WT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B929483-1F5B-E14F-BE56-F0FCAA047DE1}"/>
              </a:ext>
            </a:extLst>
          </p:cNvPr>
          <p:cNvSpPr/>
          <p:nvPr/>
        </p:nvSpPr>
        <p:spPr>
          <a:xfrm>
            <a:off x="1937423" y="700697"/>
            <a:ext cx="19191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lang="x-none"/>
            </a:pPr>
            <a:r>
              <a:rPr lang="x-non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TX, c.879C&gt;T</a:t>
            </a:r>
          </a:p>
          <a:p>
            <a:pPr algn="ctr">
              <a:defRPr lang="x-none"/>
            </a:pP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.W279*</a:t>
            </a:r>
          </a:p>
          <a:p>
            <a:pPr algn="ctr">
              <a:defRPr lang="x-none"/>
            </a:pPr>
            <a:endParaRPr lang="x-none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 lang="x-none"/>
            </a:pPr>
            <a:r>
              <a:rPr lang="x-non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2B41BEE-A898-4E4E-9E9E-980677E7EFB9}"/>
              </a:ext>
            </a:extLst>
          </p:cNvPr>
          <p:cNvSpPr txBox="1"/>
          <p:nvPr/>
        </p:nvSpPr>
        <p:spPr>
          <a:xfrm rot="17752308">
            <a:off x="2275252" y="1085867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0DC44B-00E8-3E4C-B9CC-BAEB3B255BD3}"/>
              </a:ext>
            </a:extLst>
          </p:cNvPr>
          <p:cNvSpPr txBox="1"/>
          <p:nvPr/>
        </p:nvSpPr>
        <p:spPr>
          <a:xfrm rot="17752308">
            <a:off x="2729357" y="1130473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92F7F4-7EDD-4949-94AD-883E80463C3B}"/>
              </a:ext>
            </a:extLst>
          </p:cNvPr>
          <p:cNvSpPr txBox="1"/>
          <p:nvPr/>
        </p:nvSpPr>
        <p:spPr>
          <a:xfrm rot="17752308">
            <a:off x="3204483" y="1118108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43DF6A-FB01-0543-A680-EDD7122A7BCF}"/>
              </a:ext>
            </a:extLst>
          </p:cNvPr>
          <p:cNvSpPr txBox="1"/>
          <p:nvPr/>
        </p:nvSpPr>
        <p:spPr>
          <a:xfrm rot="17752308">
            <a:off x="3690502" y="1095586"/>
            <a:ext cx="964294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 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302205D-8444-BE4A-8715-FFD185F6ECFB}"/>
              </a:ext>
            </a:extLst>
          </p:cNvPr>
          <p:cNvSpPr txBox="1"/>
          <p:nvPr/>
        </p:nvSpPr>
        <p:spPr>
          <a:xfrm rot="17752308">
            <a:off x="4174181" y="1085867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EF73EC-C89B-5740-B1B5-D3EE3871CD7A}"/>
              </a:ext>
            </a:extLst>
          </p:cNvPr>
          <p:cNvSpPr txBox="1"/>
          <p:nvPr/>
        </p:nvSpPr>
        <p:spPr>
          <a:xfrm rot="17752308">
            <a:off x="5668238" y="1130472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65BEDAF-220A-7347-9BEF-22870AA27FD0}"/>
              </a:ext>
            </a:extLst>
          </p:cNvPr>
          <p:cNvSpPr txBox="1"/>
          <p:nvPr/>
        </p:nvSpPr>
        <p:spPr>
          <a:xfrm rot="17752308">
            <a:off x="5184027" y="1118108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4CA8DB-0F70-464A-A2D2-575BCF4004C4}"/>
              </a:ext>
            </a:extLst>
          </p:cNvPr>
          <p:cNvSpPr txBox="1"/>
          <p:nvPr/>
        </p:nvSpPr>
        <p:spPr>
          <a:xfrm rot="17752308">
            <a:off x="4678962" y="1118109"/>
            <a:ext cx="964293" cy="28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l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3C2FB12-2411-384A-806E-F594C2F1384C}"/>
              </a:ext>
            </a:extLst>
          </p:cNvPr>
          <p:cNvSpPr txBox="1"/>
          <p:nvPr/>
        </p:nvSpPr>
        <p:spPr>
          <a:xfrm>
            <a:off x="1036414" y="2525298"/>
            <a:ext cx="11775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sz="16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1EA92C6-B37D-894D-93B5-5FF3BB799041}"/>
              </a:ext>
            </a:extLst>
          </p:cNvPr>
          <p:cNvSpPr txBox="1"/>
          <p:nvPr/>
        </p:nvSpPr>
        <p:spPr>
          <a:xfrm>
            <a:off x="6303263" y="2554732"/>
            <a:ext cx="12382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 actin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08A4F3F-ED99-544A-9381-DCA9611DADA9}"/>
              </a:ext>
            </a:extLst>
          </p:cNvPr>
          <p:cNvCxnSpPr/>
          <p:nvPr/>
        </p:nvCxnSpPr>
        <p:spPr>
          <a:xfrm>
            <a:off x="1867009" y="2776469"/>
            <a:ext cx="1782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ADD8321-AD36-D64C-9CFE-60FB3DAD17B3}"/>
              </a:ext>
            </a:extLst>
          </p:cNvPr>
          <p:cNvCxnSpPr/>
          <p:nvPr/>
        </p:nvCxnSpPr>
        <p:spPr>
          <a:xfrm flipV="1">
            <a:off x="4337140" y="1171115"/>
            <a:ext cx="1750379" cy="796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ABFDA3B-D7AF-5449-BD77-833ED922EA13}"/>
              </a:ext>
            </a:extLst>
          </p:cNvPr>
          <p:cNvCxnSpPr/>
          <p:nvPr/>
        </p:nvCxnSpPr>
        <p:spPr>
          <a:xfrm flipV="1">
            <a:off x="2070519" y="1179081"/>
            <a:ext cx="1750379" cy="7966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" name="Picture 24">
            <a:extLst>
              <a:ext uri="{FF2B5EF4-FFF2-40B4-BE49-F238E27FC236}">
                <a16:creationId xmlns:a16="http://schemas.microsoft.com/office/drawing/2014/main" id="{994D4B01-CCB4-644B-A29B-CA496EDE9D00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7000"/>
                    </a14:imgEffect>
                    <a14:imgEffect>
                      <a14:brightnessContrast bright="-26000" contrast="62000"/>
                    </a14:imgEffect>
                  </a14:imgLayer>
                </a14:imgProps>
              </a:ext>
            </a:extLst>
          </a:blip>
          <a:srcRect l="14837" t="337" r="3117" b="6537"/>
          <a:stretch/>
        </p:blipFill>
        <p:spPr>
          <a:xfrm>
            <a:off x="1777503" y="1678636"/>
            <a:ext cx="4517705" cy="3415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238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0</TotalTime>
  <Words>73</Words>
  <Application>Microsoft Macintosh PowerPoint</Application>
  <PresentationFormat>On-screen Show (4:3)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OS LG+CM</dc:title>
  <dc:creator>CTC</dc:creator>
  <cp:lastModifiedBy>Nidaa Ababneh</cp:lastModifiedBy>
  <cp:revision>14</cp:revision>
  <dcterms:created xsi:type="dcterms:W3CDTF">2020-07-05T09:08:30Z</dcterms:created>
  <dcterms:modified xsi:type="dcterms:W3CDTF">2020-07-07T13:24:40Z</dcterms:modified>
</cp:coreProperties>
</file>